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56" r:id="rId2"/>
    <p:sldId id="278" r:id="rId3"/>
    <p:sldId id="277" r:id="rId4"/>
    <p:sldId id="280" r:id="rId5"/>
    <p:sldId id="282" r:id="rId6"/>
  </p:sldIdLst>
  <p:sldSz cx="6858000" cy="9144000" type="letter"/>
  <p:notesSz cx="7077075" cy="9363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A4E91A01-FDC1-43AD-B8DE-0EAB81217B6C}">
          <p14:sldIdLst>
            <p14:sldId id="256"/>
          </p14:sldIdLst>
        </p14:section>
        <p14:section name="Untitled Section" id="{C41C6C0A-127C-41D9-8A3A-8C0A592ECC5A}">
          <p14:sldIdLst>
            <p14:sldId id="278"/>
            <p14:sldId id="277"/>
            <p14:sldId id="280"/>
            <p14:sldId id="282"/>
          </p14:sldIdLst>
        </p14:section>
        <p14:section name="NOT INCLUDED" id="{FB66E06B-5ED6-4D78-815C-FB8297C9C9B0}">
          <p14:sldIdLst/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24E8E6A-DAC3-4CA7-9875-37D92FD0063C}" v="14" dt="2024-08-28T18:21:29.13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51" autoAdjust="0"/>
  </p:normalViewPr>
  <p:slideViewPr>
    <p:cSldViewPr snapToGrid="0" showGuides="1">
      <p:cViewPr>
        <p:scale>
          <a:sx n="125" d="100"/>
          <a:sy n="125" d="100"/>
        </p:scale>
        <p:origin x="696" y="-18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eum, Dongil" userId="1abe38ef-9279-44b2-b962-b7577591c484" providerId="ADAL" clId="{724E8E6A-DAC3-4CA7-9875-37D92FD0063C}"/>
    <pc:docChg chg="undo custSel delSld modSld modSection">
      <pc:chgData name="Keum, Dongil" userId="1abe38ef-9279-44b2-b962-b7577591c484" providerId="ADAL" clId="{724E8E6A-DAC3-4CA7-9875-37D92FD0063C}" dt="2024-08-28T19:06:00.413" v="1346" actId="20577"/>
      <pc:docMkLst>
        <pc:docMk/>
      </pc:docMkLst>
      <pc:sldChg chg="modSp mod">
        <pc:chgData name="Keum, Dongil" userId="1abe38ef-9279-44b2-b962-b7577591c484" providerId="ADAL" clId="{724E8E6A-DAC3-4CA7-9875-37D92FD0063C}" dt="2024-08-28T19:05:43.293" v="1342" actId="20577"/>
        <pc:sldMkLst>
          <pc:docMk/>
          <pc:sldMk cId="3415019955" sldId="277"/>
        </pc:sldMkLst>
        <pc:spChg chg="mod">
          <ac:chgData name="Keum, Dongil" userId="1abe38ef-9279-44b2-b962-b7577591c484" providerId="ADAL" clId="{724E8E6A-DAC3-4CA7-9875-37D92FD0063C}" dt="2024-08-28T19:05:43.293" v="1342" actId="20577"/>
          <ac:spMkLst>
            <pc:docMk/>
            <pc:sldMk cId="3415019955" sldId="277"/>
            <ac:spMk id="10" creationId="{0742A455-7A84-117C-7259-A3E82A19BC3B}"/>
          </ac:spMkLst>
        </pc:spChg>
      </pc:sldChg>
      <pc:sldChg chg="modSp mod">
        <pc:chgData name="Keum, Dongil" userId="1abe38ef-9279-44b2-b962-b7577591c484" providerId="ADAL" clId="{724E8E6A-DAC3-4CA7-9875-37D92FD0063C}" dt="2024-08-28T19:05:33.670" v="1339" actId="20577"/>
        <pc:sldMkLst>
          <pc:docMk/>
          <pc:sldMk cId="1367860545" sldId="278"/>
        </pc:sldMkLst>
        <pc:spChg chg="mod">
          <ac:chgData name="Keum, Dongil" userId="1abe38ef-9279-44b2-b962-b7577591c484" providerId="ADAL" clId="{724E8E6A-DAC3-4CA7-9875-37D92FD0063C}" dt="2024-08-28T19:05:33.670" v="1339" actId="20577"/>
          <ac:spMkLst>
            <pc:docMk/>
            <pc:sldMk cId="1367860545" sldId="278"/>
            <ac:spMk id="8" creationId="{8A51E279-C95A-8A63-5961-AB4AA6E94096}"/>
          </ac:spMkLst>
        </pc:spChg>
      </pc:sldChg>
      <pc:sldChg chg="addSp delSp modSp del mod">
        <pc:chgData name="Keum, Dongil" userId="1abe38ef-9279-44b2-b962-b7577591c484" providerId="ADAL" clId="{724E8E6A-DAC3-4CA7-9875-37D92FD0063C}" dt="2024-08-28T18:50:51.928" v="1311" actId="2696"/>
        <pc:sldMkLst>
          <pc:docMk/>
          <pc:sldMk cId="1783400203" sldId="279"/>
        </pc:sldMkLst>
        <pc:spChg chg="mod">
          <ac:chgData name="Keum, Dongil" userId="1abe38ef-9279-44b2-b962-b7577591c484" providerId="ADAL" clId="{724E8E6A-DAC3-4CA7-9875-37D92FD0063C}" dt="2024-08-28T18:36:45.846" v="1304" actId="20577"/>
          <ac:spMkLst>
            <pc:docMk/>
            <pc:sldMk cId="1783400203" sldId="279"/>
            <ac:spMk id="8" creationId="{2FADA90A-F815-42F3-EFCC-7BF0D9B686D5}"/>
          </ac:spMkLst>
        </pc:spChg>
        <pc:graphicFrameChg chg="add mod modGraphic">
          <ac:chgData name="Keum, Dongil" userId="1abe38ef-9279-44b2-b962-b7577591c484" providerId="ADAL" clId="{724E8E6A-DAC3-4CA7-9875-37D92FD0063C}" dt="2024-08-28T18:21:21.124" v="972" actId="404"/>
          <ac:graphicFrameMkLst>
            <pc:docMk/>
            <pc:sldMk cId="1783400203" sldId="279"/>
            <ac:graphicFrameMk id="2" creationId="{BE9C241E-BC56-8DEF-02CF-3112EDECBC68}"/>
          </ac:graphicFrameMkLst>
        </pc:graphicFrameChg>
        <pc:graphicFrameChg chg="del mod modGraphic">
          <ac:chgData name="Keum, Dongil" userId="1abe38ef-9279-44b2-b962-b7577591c484" providerId="ADAL" clId="{724E8E6A-DAC3-4CA7-9875-37D92FD0063C}" dt="2024-08-28T18:12:43.357" v="863" actId="478"/>
          <ac:graphicFrameMkLst>
            <pc:docMk/>
            <pc:sldMk cId="1783400203" sldId="279"/>
            <ac:graphicFrameMk id="11" creationId="{4DE25C40-24CF-6403-981C-DFFCAF0D4951}"/>
          </ac:graphicFrameMkLst>
        </pc:graphicFrameChg>
      </pc:sldChg>
      <pc:sldChg chg="modSp mod">
        <pc:chgData name="Keum, Dongil" userId="1abe38ef-9279-44b2-b962-b7577591c484" providerId="ADAL" clId="{724E8E6A-DAC3-4CA7-9875-37D92FD0063C}" dt="2024-08-28T19:05:52.494" v="1344" actId="20577"/>
        <pc:sldMkLst>
          <pc:docMk/>
          <pc:sldMk cId="3684551778" sldId="280"/>
        </pc:sldMkLst>
        <pc:spChg chg="mod">
          <ac:chgData name="Keum, Dongil" userId="1abe38ef-9279-44b2-b962-b7577591c484" providerId="ADAL" clId="{724E8E6A-DAC3-4CA7-9875-37D92FD0063C}" dt="2024-08-28T19:05:52.494" v="1344" actId="20577"/>
          <ac:spMkLst>
            <pc:docMk/>
            <pc:sldMk cId="3684551778" sldId="280"/>
            <ac:spMk id="12" creationId="{8A85B3E7-9F38-2C55-9753-A3140C1416B7}"/>
          </ac:spMkLst>
        </pc:spChg>
      </pc:sldChg>
      <pc:sldChg chg="modSp mod">
        <pc:chgData name="Keum, Dongil" userId="1abe38ef-9279-44b2-b962-b7577591c484" providerId="ADAL" clId="{724E8E6A-DAC3-4CA7-9875-37D92FD0063C}" dt="2024-08-28T19:06:00.413" v="1346" actId="20577"/>
        <pc:sldMkLst>
          <pc:docMk/>
          <pc:sldMk cId="1013062755" sldId="282"/>
        </pc:sldMkLst>
        <pc:spChg chg="mod">
          <ac:chgData name="Keum, Dongil" userId="1abe38ef-9279-44b2-b962-b7577591c484" providerId="ADAL" clId="{724E8E6A-DAC3-4CA7-9875-37D92FD0063C}" dt="2024-08-28T19:06:00.413" v="1346" actId="20577"/>
          <ac:spMkLst>
            <pc:docMk/>
            <pc:sldMk cId="1013062755" sldId="282"/>
            <ac:spMk id="12" creationId="{8A85B3E7-9F38-2C55-9753-A3140C1416B7}"/>
          </ac:spMkLst>
        </pc:spChg>
      </pc:sldChg>
      <pc:sldChg chg="addSp delSp modSp del mod">
        <pc:chgData name="Keum, Dongil" userId="1abe38ef-9279-44b2-b962-b7577591c484" providerId="ADAL" clId="{724E8E6A-DAC3-4CA7-9875-37D92FD0063C}" dt="2024-08-28T18:50:51.928" v="1311" actId="2696"/>
        <pc:sldMkLst>
          <pc:docMk/>
          <pc:sldMk cId="366498257" sldId="283"/>
        </pc:sldMkLst>
        <pc:spChg chg="add del mod">
          <ac:chgData name="Keum, Dongil" userId="1abe38ef-9279-44b2-b962-b7577591c484" providerId="ADAL" clId="{724E8E6A-DAC3-4CA7-9875-37D92FD0063C}" dt="2024-08-28T18:16:55.164" v="909" actId="478"/>
          <ac:spMkLst>
            <pc:docMk/>
            <pc:sldMk cId="366498257" sldId="283"/>
            <ac:spMk id="3" creationId="{5A513D72-DBB1-C0B9-FD0D-5920328A4125}"/>
          </ac:spMkLst>
        </pc:spChg>
        <pc:spChg chg="mod">
          <ac:chgData name="Keum, Dongil" userId="1abe38ef-9279-44b2-b962-b7577591c484" providerId="ADAL" clId="{724E8E6A-DAC3-4CA7-9875-37D92FD0063C}" dt="2024-08-28T18:37:17.543" v="1310" actId="20577"/>
          <ac:spMkLst>
            <pc:docMk/>
            <pc:sldMk cId="366498257" sldId="283"/>
            <ac:spMk id="5" creationId="{387C61B2-149D-D68B-EA35-D32E6A6A2BD9}"/>
          </ac:spMkLst>
        </pc:spChg>
        <pc:graphicFrameChg chg="del mod modGraphic">
          <ac:chgData name="Keum, Dongil" userId="1abe38ef-9279-44b2-b962-b7577591c484" providerId="ADAL" clId="{724E8E6A-DAC3-4CA7-9875-37D92FD0063C}" dt="2024-08-28T18:16:52.378" v="908" actId="478"/>
          <ac:graphicFrameMkLst>
            <pc:docMk/>
            <pc:sldMk cId="366498257" sldId="283"/>
            <ac:graphicFrameMk id="4" creationId="{7F1ACE66-F34C-347C-7984-81A0A69D4DA8}"/>
          </ac:graphicFrameMkLst>
        </pc:graphicFrameChg>
        <pc:graphicFrameChg chg="add mod modGraphic">
          <ac:chgData name="Keum, Dongil" userId="1abe38ef-9279-44b2-b962-b7577591c484" providerId="ADAL" clId="{724E8E6A-DAC3-4CA7-9875-37D92FD0063C}" dt="2024-08-28T18:21:35.428" v="974" actId="403"/>
          <ac:graphicFrameMkLst>
            <pc:docMk/>
            <pc:sldMk cId="366498257" sldId="283"/>
            <ac:graphicFrameMk id="6" creationId="{4C69EFA8-F261-96AB-DAC8-CF8A7D396E43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66733" cy="469779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08705" y="0"/>
            <a:ext cx="3066733" cy="469779"/>
          </a:xfrm>
          <a:prstGeom prst="rect">
            <a:avLst/>
          </a:prstGeom>
        </p:spPr>
        <p:txBody>
          <a:bodyPr vert="horz" lIns="96341" tIns="48171" rIns="96341" bIns="48171" rtlCol="0"/>
          <a:lstStyle>
            <a:lvl1pPr algn="r">
              <a:defRPr sz="1300"/>
            </a:lvl1pPr>
          </a:lstStyle>
          <a:p>
            <a:fld id="{84BC5BD6-2CCD-4F39-BC9E-9C29CB1D2CED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169988"/>
            <a:ext cx="2368550" cy="31591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341" tIns="48171" rIns="96341" bIns="4817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7708" y="4505980"/>
            <a:ext cx="5661660" cy="3686711"/>
          </a:xfrm>
          <a:prstGeom prst="rect">
            <a:avLst/>
          </a:prstGeom>
        </p:spPr>
        <p:txBody>
          <a:bodyPr vert="horz" lIns="96341" tIns="48171" rIns="96341" bIns="4817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93297"/>
            <a:ext cx="3066733" cy="469778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08705" y="8893297"/>
            <a:ext cx="3066733" cy="469778"/>
          </a:xfrm>
          <a:prstGeom prst="rect">
            <a:avLst/>
          </a:prstGeom>
        </p:spPr>
        <p:txBody>
          <a:bodyPr vert="horz" lIns="96341" tIns="48171" rIns="96341" bIns="48171" rtlCol="0" anchor="b"/>
          <a:lstStyle>
            <a:lvl1pPr algn="r">
              <a:defRPr sz="1300"/>
            </a:lvl1pPr>
          </a:lstStyle>
          <a:p>
            <a:fld id="{CAE3AD49-20B3-4EC3-9CF1-ABD93734DF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7539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99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530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226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098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921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103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90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844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899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509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047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F90576B-43B1-4646-9485-A0666AED87CA}" type="datetimeFigureOut">
              <a:rPr lang="en-US" smtClean="0"/>
              <a:t>8/2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7E894E-11A8-478A-A593-F2A8F58623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455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ABAE44-47AD-7625-1C44-E3CDD7C5A55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 anchor="ctr">
            <a:norm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 Mathematical Sequence Representing </a:t>
            </a:r>
            <a:br>
              <a:rPr lang="en-US" sz="280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2800">
                <a:latin typeface="Arial" panose="020B0604020202020204" pitchFamily="34" charset="0"/>
                <a:cs typeface="Arial" panose="020B0604020202020204" pitchFamily="34" charset="0"/>
              </a:rPr>
              <a:t>Tonic </a:t>
            </a:r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ction Potential Spike Train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86683D-9900-70C9-9D1C-5D42603B86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514350" y="4802717"/>
            <a:ext cx="5981700" cy="3103033"/>
          </a:xfrm>
        </p:spPr>
        <p:txBody>
          <a:bodyPr>
            <a:normAutofit/>
          </a:bodyPr>
          <a:lstStyle/>
          <a:p>
            <a:pPr algn="l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ngil Keu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*</a:t>
            </a:r>
          </a:p>
          <a:p>
            <a:pPr algn="l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won-Woo Ki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  <a:p>
            <a:pPr algn="l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lly Pruitt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l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lexandre E. Medina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, 2</a:t>
            </a:r>
          </a:p>
          <a:p>
            <a:pPr algn="l"/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sz="1200" kern="100" baseline="30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</a:t>
            </a:r>
            <a:r>
              <a:rPr lang="en-US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VA Maryland Health Care System, Baltimore, Maryland, United States 21201</a:t>
            </a:r>
            <a:endParaRPr lang="en-US" sz="1200" baseline="30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lang="en-US" sz="1200" kern="100" baseline="30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2</a:t>
            </a:r>
            <a:r>
              <a:rPr lang="en-US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epartment of Pediatrics, University of Maryland School of Medicine, Baltimore, Maryland, United States 21201</a:t>
            </a:r>
          </a:p>
          <a:p>
            <a:pPr algn="l"/>
            <a:r>
              <a:rPr lang="en-US" sz="1200" kern="100" baseline="30000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3</a:t>
            </a:r>
            <a:r>
              <a:rPr lang="en-US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Korea Brain Research Institute, Daegu, South Korea 41062</a:t>
            </a:r>
          </a:p>
          <a:p>
            <a:pPr algn="l"/>
            <a:r>
              <a:rPr lang="en-US" sz="1200" kern="100" dirty="0"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*Corresponding Author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45CF42-7FB7-E451-14BE-DD352F2AB7B3}"/>
              </a:ext>
            </a:extLst>
          </p:cNvPr>
          <p:cNvSpPr txBox="1"/>
          <p:nvPr/>
        </p:nvSpPr>
        <p:spPr>
          <a:xfrm>
            <a:off x="231648" y="316992"/>
            <a:ext cx="3003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Data Figures</a:t>
            </a:r>
          </a:p>
        </p:txBody>
      </p:sp>
    </p:spTree>
    <p:extLst>
      <p:ext uri="{BB962C8B-B14F-4D97-AF65-F5344CB8AC3E}">
        <p14:creationId xmlns:p14="http://schemas.microsoft.com/office/powerpoint/2010/main" val="1753295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D8ED464-132D-81C2-A0B0-0BBD5A356D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8305" y="2024453"/>
            <a:ext cx="5526755" cy="26517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A51E279-C95A-8A63-5961-AB4AA6E94096}"/>
              </a:ext>
            </a:extLst>
          </p:cNvPr>
          <p:cNvSpPr txBox="1"/>
          <p:nvPr/>
        </p:nvSpPr>
        <p:spPr>
          <a:xfrm>
            <a:off x="330366" y="5386605"/>
            <a:ext cx="58626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cumulativ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nterspik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terval of individual neuron arranged by their 1st ISI.</a:t>
            </a:r>
          </a:p>
        </p:txBody>
      </p:sp>
    </p:spTree>
    <p:extLst>
      <p:ext uri="{BB962C8B-B14F-4D97-AF65-F5344CB8AC3E}">
        <p14:creationId xmlns:p14="http://schemas.microsoft.com/office/powerpoint/2010/main" val="13678605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BE7648EE-2D26-7F4F-0B6F-C8F80B1AA6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955" y="1155312"/>
            <a:ext cx="2438400" cy="1828800"/>
          </a:xfrm>
          <a:prstGeom prst="rect">
            <a:avLst/>
          </a:prstGeom>
        </p:spPr>
      </p:pic>
      <p:pic>
        <p:nvPicPr>
          <p:cNvPr id="16" name="Picture 15" descr="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7A294A3E-2EA0-A5D4-844E-8023B8EAB9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928" y="1155312"/>
            <a:ext cx="2438400" cy="18288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E9C93F3-A623-3A99-A2BC-0DC96195C02E}"/>
              </a:ext>
            </a:extLst>
          </p:cNvPr>
          <p:cNvSpPr txBox="1"/>
          <p:nvPr/>
        </p:nvSpPr>
        <p:spPr>
          <a:xfrm>
            <a:off x="499673" y="10014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5277949-8C3C-EDD0-035D-ACDD2BB6A51C}"/>
              </a:ext>
            </a:extLst>
          </p:cNvPr>
          <p:cNvSpPr txBox="1"/>
          <p:nvPr/>
        </p:nvSpPr>
        <p:spPr>
          <a:xfrm>
            <a:off x="3187700" y="100142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742A455-7A84-117C-7259-A3E82A19BC3B}"/>
              </a:ext>
            </a:extLst>
          </p:cNvPr>
          <p:cNvSpPr txBox="1"/>
          <p:nvPr/>
        </p:nvSpPr>
        <p:spPr>
          <a:xfrm>
            <a:off x="337080" y="4280649"/>
            <a:ext cx="58626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slope (A) and intercept (B) obtained through linear regression of the leading (x-axis) and following (y-axis) ISIs from each combination of injected current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inj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ISI number (n) are shown.</a:t>
            </a:r>
          </a:p>
        </p:txBody>
      </p:sp>
    </p:spTree>
    <p:extLst>
      <p:ext uri="{BB962C8B-B14F-4D97-AF65-F5344CB8AC3E}">
        <p14:creationId xmlns:p14="http://schemas.microsoft.com/office/powerpoint/2010/main" val="34150199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8A85B3E7-9F38-2C55-9753-A3140C1416B7}"/>
              </a:ext>
            </a:extLst>
          </p:cNvPr>
          <p:cNvSpPr txBox="1"/>
          <p:nvPr/>
        </p:nvSpPr>
        <p:spPr>
          <a:xfrm>
            <a:off x="444101" y="4794052"/>
            <a:ext cx="616566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lation between preceding peak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AH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uration and the numb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queunc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A) Correlation of normalized timing precursor and normalized peak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AH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B) Correlation of peak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AH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current ISI. Correlation calculated by Pearson’s correlation coefficient. The blue lines represent linear regression lines fitted using the least squares method that maximizes R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pic>
        <p:nvPicPr>
          <p:cNvPr id="14" name="Picture 13" descr="A graph of a diagram&#10;&#10;Description automatically generated with medium confidence">
            <a:extLst>
              <a:ext uri="{FF2B5EF4-FFF2-40B4-BE49-F238E27FC236}">
                <a16:creationId xmlns:a16="http://schemas.microsoft.com/office/drawing/2014/main" id="{5EEAE9A1-5A33-2500-A0D4-17924F1CF4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101" y="1492049"/>
            <a:ext cx="5715798" cy="285789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EEAC3D4-9BF5-3CCE-03CC-98C8390A22AC}"/>
              </a:ext>
            </a:extLst>
          </p:cNvPr>
          <p:cNvSpPr txBox="1"/>
          <p:nvPr/>
        </p:nvSpPr>
        <p:spPr>
          <a:xfrm>
            <a:off x="286846" y="11842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88C6C8F-1B69-631F-CE39-02738A4C2123}"/>
              </a:ext>
            </a:extLst>
          </p:cNvPr>
          <p:cNvSpPr txBox="1"/>
          <p:nvPr/>
        </p:nvSpPr>
        <p:spPr>
          <a:xfrm>
            <a:off x="3254979" y="11842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45517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8A85B3E7-9F38-2C55-9753-A3140C1416B7}"/>
              </a:ext>
            </a:extLst>
          </p:cNvPr>
          <p:cNvSpPr txBox="1"/>
          <p:nvPr/>
        </p:nvSpPr>
        <p:spPr>
          <a:xfrm>
            <a:off x="444101" y="4794052"/>
            <a:ext cx="6165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lation between precedin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AH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mplitude and the numbe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equeunc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(A) Change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AH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upon ISI order. (B) Correlation of normalized timing precursor and normaliz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AH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The blue line represents the linear regression line.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r = 0.08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&lt;0.0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3CCE4AE3-40DD-B5AA-F6D9-46A7E580DB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571500" y="1714500"/>
            <a:ext cx="5715000" cy="285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30627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825</TotalTime>
  <Words>252</Words>
  <Application>Microsoft Office PowerPoint</Application>
  <PresentationFormat>Letter Paper (8.5x11 in)</PresentationFormat>
  <Paragraphs>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A Mathematical Sequence Representing  Tonic Action Potential Spike Train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um, Dongil</dc:creator>
  <cp:lastModifiedBy>Keum, Dongil</cp:lastModifiedBy>
  <cp:revision>4</cp:revision>
  <cp:lastPrinted>2024-04-29T18:38:59Z</cp:lastPrinted>
  <dcterms:created xsi:type="dcterms:W3CDTF">2024-03-15T02:17:22Z</dcterms:created>
  <dcterms:modified xsi:type="dcterms:W3CDTF">2024-08-28T19:06:02Z</dcterms:modified>
</cp:coreProperties>
</file>